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70B45C-B587-457F-B5BE-A5BB0A06CEA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63F8F0-A156-4F70-8691-A8E445EAC4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5EA140-AD41-42D0-A648-C506777A924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0BE6B8-FAB7-4EC2-8FA9-5FBDA2F4A65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DDB504-5FB7-4F96-B742-4D033728DA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CE4861-0683-485F-8FB9-FDDC16DD9D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9454F8-C2F3-4D50-8EF1-E0C256D54E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C3C9E1-A279-45E2-A990-CED0A96B4F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C1A6FF-A63F-4F7F-8E74-3B64C7465B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556FAD-96E1-4FF4-B438-AC7876C621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D9DBBE-B04F-4C79-8A4A-D844C96086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73F9AE-53A4-403A-BF05-C3089C4D05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C81712D-F73C-47C3-9ECC-839F7A1597F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358920" y="198360"/>
            <a:ext cx="10144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3.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Unsupervised variable clustering to evaluate correlations between variables associated with primary outcomes among resident, fellow, junior faculty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image2.png" descr="A screenshot of a computer screen&#10;&#10;Description automatically generated with medium confidence"/>
          <p:cNvPicPr/>
          <p:nvPr/>
        </p:nvPicPr>
        <p:blipFill>
          <a:blip r:embed="rId1"/>
          <a:stretch/>
        </p:blipFill>
        <p:spPr>
          <a:xfrm>
            <a:off x="3568680" y="800280"/>
            <a:ext cx="6551640" cy="6057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5-30T19:36:09Z</dcterms:created>
  <dc:creator>Omar Toubat</dc:creator>
  <dc:description/>
  <dc:language>en-US</dc:language>
  <cp:lastModifiedBy>Toubat, Omar</cp:lastModifiedBy>
  <dcterms:modified xsi:type="dcterms:W3CDTF">2024-04-16T20:03:45Z</dcterms:modified>
  <cp:revision>53</cp:revision>
  <dc:subject/>
  <dc:title>PowerPoint Presentation</dc:title>
</cp:coreProperties>
</file>